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6" r:id="rId2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016" autoAdjust="0"/>
    <p:restoredTop sz="94660"/>
  </p:normalViewPr>
  <p:slideViewPr>
    <p:cSldViewPr snapToGrid="0">
      <p:cViewPr varScale="1">
        <p:scale>
          <a:sx n="80" d="100"/>
          <a:sy n="80" d="100"/>
        </p:scale>
        <p:origin x="612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fr-FR"/>
              <a:t>Modifiez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A0122B-8D88-4B02-9A9A-B9228F0B7318}" type="datetimeFigureOut">
              <a:rPr lang="fr-FR" smtClean="0"/>
              <a:t>11/09/2023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E5BBB7-292B-4B07-992B-21DFBA5BE54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6577985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A0122B-8D88-4B02-9A9A-B9228F0B7318}" type="datetimeFigureOut">
              <a:rPr lang="fr-FR" smtClean="0"/>
              <a:t>11/09/2023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E5BBB7-292B-4B07-992B-21DFBA5BE54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75304950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A0122B-8D88-4B02-9A9A-B9228F0B7318}" type="datetimeFigureOut">
              <a:rPr lang="fr-FR" smtClean="0"/>
              <a:t>11/09/2023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E5BBB7-292B-4B07-992B-21DFBA5BE54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74103389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A0122B-8D88-4B02-9A9A-B9228F0B7318}" type="datetimeFigureOut">
              <a:rPr lang="fr-FR" smtClean="0"/>
              <a:t>11/09/2023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E5BBB7-292B-4B07-992B-21DFBA5BE54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77709938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A0122B-8D88-4B02-9A9A-B9228F0B7318}" type="datetimeFigureOut">
              <a:rPr lang="fr-FR" smtClean="0"/>
              <a:t>11/09/2023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E5BBB7-292B-4B07-992B-21DFBA5BE54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67282951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A0122B-8D88-4B02-9A9A-B9228F0B7318}" type="datetimeFigureOut">
              <a:rPr lang="fr-FR" smtClean="0"/>
              <a:t>11/09/2023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E5BBB7-292B-4B07-992B-21DFBA5BE54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17165446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A0122B-8D88-4B02-9A9A-B9228F0B7318}" type="datetimeFigureOut">
              <a:rPr lang="fr-FR" smtClean="0"/>
              <a:t>11/09/2023</a:t>
            </a:fld>
            <a:endParaRPr lang="fr-F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E5BBB7-292B-4B07-992B-21DFBA5BE54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22046807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A0122B-8D88-4B02-9A9A-B9228F0B7318}" type="datetimeFigureOut">
              <a:rPr lang="fr-FR" smtClean="0"/>
              <a:t>11/09/2023</a:t>
            </a:fld>
            <a:endParaRPr lang="fr-F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E5BBB7-292B-4B07-992B-21DFBA5BE54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67255145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A0122B-8D88-4B02-9A9A-B9228F0B7318}" type="datetimeFigureOut">
              <a:rPr lang="fr-FR" smtClean="0"/>
              <a:t>11/09/2023</a:t>
            </a:fld>
            <a:endParaRPr lang="fr-F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E5BBB7-292B-4B07-992B-21DFBA5BE54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90957155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A0122B-8D88-4B02-9A9A-B9228F0B7318}" type="datetimeFigureOut">
              <a:rPr lang="fr-FR" smtClean="0"/>
              <a:t>11/09/2023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E5BBB7-292B-4B07-992B-21DFBA5BE54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4928382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fr-FR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A0122B-8D88-4B02-9A9A-B9228F0B7318}" type="datetimeFigureOut">
              <a:rPr lang="fr-FR" smtClean="0"/>
              <a:t>11/09/2023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E5BBB7-292B-4B07-992B-21DFBA5BE54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25455255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0A0122B-8D88-4B02-9A9A-B9228F0B7318}" type="datetimeFigureOut">
              <a:rPr lang="fr-FR" smtClean="0"/>
              <a:t>11/09/2023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DE5BBB7-292B-4B07-992B-21DFBA5BE54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37842118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ZoneTexte 4">
            <a:extLst>
              <a:ext uri="{FF2B5EF4-FFF2-40B4-BE49-F238E27FC236}">
                <a16:creationId xmlns:a16="http://schemas.microsoft.com/office/drawing/2014/main" id="{0CECCE0D-130B-4D79-97F8-BC119032B6FA}"/>
              </a:ext>
            </a:extLst>
          </p:cNvPr>
          <p:cNvSpPr txBox="1"/>
          <p:nvPr/>
        </p:nvSpPr>
        <p:spPr>
          <a:xfrm>
            <a:off x="273974" y="507419"/>
            <a:ext cx="6033838" cy="97667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en-US" sz="12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Unprocessed Fig. 1e</a:t>
            </a:r>
          </a:p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en-US" sz="12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Signal detection was performed as described in the Material and methods section of the accompanying manuscript. Red rectangles indicate the cropped images shown in the respective manuscript figures. </a:t>
            </a:r>
            <a:endParaRPr lang="fr-FR" sz="12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pic>
        <p:nvPicPr>
          <p:cNvPr id="6" name="Image 5">
            <a:extLst>
              <a:ext uri="{FF2B5EF4-FFF2-40B4-BE49-F238E27FC236}">
                <a16:creationId xmlns:a16="http://schemas.microsoft.com/office/drawing/2014/main" id="{2FE4BEC3-2BBE-437E-B4D4-5F3DFD3865B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18836" y="2171016"/>
            <a:ext cx="5944115" cy="282878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253032716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</TotalTime>
  <Words>34</Words>
  <Application>Microsoft Office PowerPoint</Application>
  <PresentationFormat>Affichage à l'écran (4:3)</PresentationFormat>
  <Paragraphs>2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hème Office</vt:lpstr>
      <vt:lpstr>Présentation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Gallois Jean-Luc</dc:creator>
  <cp:lastModifiedBy>Gallois Jean-Luc</cp:lastModifiedBy>
  <cp:revision>1</cp:revision>
  <dcterms:created xsi:type="dcterms:W3CDTF">2023-09-11T13:58:36Z</dcterms:created>
  <dcterms:modified xsi:type="dcterms:W3CDTF">2023-09-11T14:00:37Z</dcterms:modified>
</cp:coreProperties>
</file>